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awrence Ostroff" initials="LO" lastIdx="1" clrIdx="0"/>
  <p:cmAuthor id="2" name="Author" initials="Editor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1FE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865"/>
    <p:restoredTop sz="94590"/>
  </p:normalViewPr>
  <p:slideViewPr>
    <p:cSldViewPr snapToGrid="0" snapToObjects="1">
      <p:cViewPr varScale="1">
        <p:scale>
          <a:sx n="76" d="100"/>
          <a:sy n="76" d="100"/>
        </p:scale>
        <p:origin x="208" y="52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0C428-9CE9-6744-BB80-BF3F0877372E}" type="datetimeFigureOut">
              <a:rPr kumimoji="1" lang="ja-JP" altLang="en-US" smtClean="0"/>
              <a:t>2021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CD7AE-9064-3141-A7C5-29529240C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52534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0C428-9CE9-6744-BB80-BF3F0877372E}" type="datetimeFigureOut">
              <a:rPr kumimoji="1" lang="ja-JP" altLang="en-US" smtClean="0"/>
              <a:t>2021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CD7AE-9064-3141-A7C5-29529240C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67446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0C428-9CE9-6744-BB80-BF3F0877372E}" type="datetimeFigureOut">
              <a:rPr kumimoji="1" lang="ja-JP" altLang="en-US" smtClean="0"/>
              <a:t>2021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CD7AE-9064-3141-A7C5-29529240C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5540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0C428-9CE9-6744-BB80-BF3F0877372E}" type="datetimeFigureOut">
              <a:rPr kumimoji="1" lang="ja-JP" altLang="en-US" smtClean="0"/>
              <a:t>2021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CD7AE-9064-3141-A7C5-29529240C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1602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0C428-9CE9-6744-BB80-BF3F0877372E}" type="datetimeFigureOut">
              <a:rPr kumimoji="1" lang="ja-JP" altLang="en-US" smtClean="0"/>
              <a:t>2021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CD7AE-9064-3141-A7C5-29529240C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96807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0C428-9CE9-6744-BB80-BF3F0877372E}" type="datetimeFigureOut">
              <a:rPr kumimoji="1" lang="ja-JP" altLang="en-US" smtClean="0"/>
              <a:t>2021/5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CD7AE-9064-3141-A7C5-29529240C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68056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0C428-9CE9-6744-BB80-BF3F0877372E}" type="datetimeFigureOut">
              <a:rPr kumimoji="1" lang="ja-JP" altLang="en-US" smtClean="0"/>
              <a:t>2021/5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CD7AE-9064-3141-A7C5-29529240C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31874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0C428-9CE9-6744-BB80-BF3F0877372E}" type="datetimeFigureOut">
              <a:rPr kumimoji="1" lang="ja-JP" altLang="en-US" smtClean="0"/>
              <a:t>2021/5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CD7AE-9064-3141-A7C5-29529240C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6604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0C428-9CE9-6744-BB80-BF3F0877372E}" type="datetimeFigureOut">
              <a:rPr kumimoji="1" lang="ja-JP" altLang="en-US" smtClean="0"/>
              <a:t>2021/5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CD7AE-9064-3141-A7C5-29529240C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24972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0C428-9CE9-6744-BB80-BF3F0877372E}" type="datetimeFigureOut">
              <a:rPr kumimoji="1" lang="ja-JP" altLang="en-US" smtClean="0"/>
              <a:t>2021/5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CD7AE-9064-3141-A7C5-29529240C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87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0C428-9CE9-6744-BB80-BF3F0877372E}" type="datetimeFigureOut">
              <a:rPr kumimoji="1" lang="ja-JP" altLang="en-US" smtClean="0"/>
              <a:t>2021/5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ACD7AE-9064-3141-A7C5-29529240C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0100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10C428-9CE9-6744-BB80-BF3F0877372E}" type="datetimeFigureOut">
              <a:rPr kumimoji="1" lang="ja-JP" altLang="en-US" smtClean="0"/>
              <a:t>2021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ACD7AE-9064-3141-A7C5-29529240C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3108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EC7DEB7-A835-EA4F-99F0-0120064670B2}"/>
              </a:ext>
            </a:extLst>
          </p:cNvPr>
          <p:cNvSpPr txBox="1"/>
          <p:nvPr/>
        </p:nvSpPr>
        <p:spPr>
          <a:xfrm>
            <a:off x="152239" y="343248"/>
            <a:ext cx="7958091" cy="338554"/>
          </a:xfrm>
          <a:prstGeom prst="rect">
            <a:avLst/>
          </a:prstGeom>
          <a:noFill/>
          <a:ln w="38100"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men with singleton pregnancies delivering at ≥22 gestation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 weeks </a:t>
            </a:r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</a:t>
            </a:r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2904 [100%]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91DA9626-2985-0D4A-8D7A-42BABA635BD5}"/>
              </a:ext>
            </a:extLst>
          </p:cNvPr>
          <p:cNvCxnSpPr>
            <a:cxnSpLocks/>
          </p:cNvCxnSpPr>
          <p:nvPr/>
        </p:nvCxnSpPr>
        <p:spPr>
          <a:xfrm>
            <a:off x="428257" y="681802"/>
            <a:ext cx="2332" cy="3003575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5725BF4E-39B9-EE46-BEFD-387B329C13F9}"/>
              </a:ext>
            </a:extLst>
          </p:cNvPr>
          <p:cNvCxnSpPr>
            <a:cxnSpLocks/>
            <a:endCxn id="56" idx="1"/>
          </p:cNvCxnSpPr>
          <p:nvPr/>
        </p:nvCxnSpPr>
        <p:spPr>
          <a:xfrm>
            <a:off x="441984" y="1076731"/>
            <a:ext cx="272173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D27FF943-1746-F04A-B6A0-64782FBF2B52}"/>
              </a:ext>
            </a:extLst>
          </p:cNvPr>
          <p:cNvSpPr txBox="1"/>
          <p:nvPr/>
        </p:nvSpPr>
        <p:spPr>
          <a:xfrm>
            <a:off x="238384" y="3670263"/>
            <a:ext cx="8016635" cy="338554"/>
          </a:xfrm>
          <a:prstGeom prst="rect">
            <a:avLst/>
          </a:prstGeom>
          <a:noFill/>
          <a:ln w="38100"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w onset of 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pertension or proteinuria </a:t>
            </a:r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 ≥20 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stational weeks </a:t>
            </a:r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183, [6.3%]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556C8265-3B32-6C45-A203-E9EB29A7A4FE}"/>
              </a:ext>
            </a:extLst>
          </p:cNvPr>
          <p:cNvCxnSpPr>
            <a:cxnSpLocks/>
          </p:cNvCxnSpPr>
          <p:nvPr/>
        </p:nvCxnSpPr>
        <p:spPr>
          <a:xfrm>
            <a:off x="1269492" y="1246008"/>
            <a:ext cx="1" cy="339439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F449003C-C7CE-A340-AE6B-C0F9B7232912}"/>
              </a:ext>
            </a:extLst>
          </p:cNvPr>
          <p:cNvSpPr txBox="1"/>
          <p:nvPr/>
        </p:nvSpPr>
        <p:spPr>
          <a:xfrm>
            <a:off x="2866112" y="4296196"/>
            <a:ext cx="2922499" cy="584775"/>
          </a:xfrm>
          <a:prstGeom prst="rect">
            <a:avLst/>
          </a:prstGeom>
          <a:noFill/>
          <a:ln w="38100"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stational proteinuria (GP)</a:t>
            </a:r>
          </a:p>
          <a:p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14 [0.5%])*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AEB81EF6-BD39-6045-AE6D-7D87BBFD6A76}"/>
              </a:ext>
            </a:extLst>
          </p:cNvPr>
          <p:cNvCxnSpPr>
            <a:cxnSpLocks/>
          </p:cNvCxnSpPr>
          <p:nvPr/>
        </p:nvCxnSpPr>
        <p:spPr>
          <a:xfrm>
            <a:off x="6164588" y="4008817"/>
            <a:ext cx="0" cy="27731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15780213-7F7D-A34F-8499-CBC217497310}"/>
              </a:ext>
            </a:extLst>
          </p:cNvPr>
          <p:cNvSpPr txBox="1"/>
          <p:nvPr/>
        </p:nvSpPr>
        <p:spPr>
          <a:xfrm>
            <a:off x="5921341" y="4286944"/>
            <a:ext cx="2922500" cy="584775"/>
          </a:xfrm>
          <a:prstGeom prst="rect">
            <a:avLst/>
          </a:prstGeom>
          <a:noFill/>
          <a:ln w="38100"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stational hypertension (GH)</a:t>
            </a:r>
          </a:p>
          <a:p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75 [2.6%])*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8A2ECF31-F812-284D-A296-5B1B74BCCC6B}"/>
              </a:ext>
            </a:extLst>
          </p:cNvPr>
          <p:cNvCxnSpPr>
            <a:cxnSpLocks/>
          </p:cNvCxnSpPr>
          <p:nvPr/>
        </p:nvCxnSpPr>
        <p:spPr>
          <a:xfrm>
            <a:off x="428257" y="4008817"/>
            <a:ext cx="1" cy="281109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D5DA6A4D-9F62-4248-BECC-C316F4C421F8}"/>
              </a:ext>
            </a:extLst>
          </p:cNvPr>
          <p:cNvSpPr txBox="1"/>
          <p:nvPr/>
        </p:nvSpPr>
        <p:spPr>
          <a:xfrm>
            <a:off x="350515" y="4296196"/>
            <a:ext cx="2270058" cy="584775"/>
          </a:xfrm>
          <a:prstGeom prst="rect">
            <a:avLst/>
          </a:prstGeom>
          <a:noFill/>
          <a:ln w="38100"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eclampsia</a:t>
            </a:r>
          </a:p>
          <a:p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94 [3.2%])</a:t>
            </a:r>
            <a:endParaRPr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E4CB2564-3A86-F24E-B79D-16B015133F15}"/>
              </a:ext>
            </a:extLst>
          </p:cNvPr>
          <p:cNvSpPr txBox="1"/>
          <p:nvPr/>
        </p:nvSpPr>
        <p:spPr>
          <a:xfrm>
            <a:off x="682877" y="1606804"/>
            <a:ext cx="4501373" cy="338554"/>
          </a:xfrm>
          <a:prstGeom prst="rect">
            <a:avLst/>
          </a:prstGeom>
          <a:noFill/>
          <a:ln w="38100"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erimposed-type preeclampsia (</a:t>
            </a:r>
            <a:r>
              <a:rPr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31 [1.1%]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F861C75A-C7BA-A941-B944-3147DBDBDA2F}"/>
              </a:ext>
            </a:extLst>
          </p:cNvPr>
          <p:cNvSpPr txBox="1"/>
          <p:nvPr/>
        </p:nvSpPr>
        <p:spPr>
          <a:xfrm>
            <a:off x="714157" y="907454"/>
            <a:ext cx="6442017" cy="338554"/>
          </a:xfrm>
          <a:prstGeom prst="rect">
            <a:avLst/>
          </a:prstGeom>
          <a:noFill/>
          <a:ln w="38100"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hypertension or kidney diseases before pregnancy </a:t>
            </a:r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83 [2.9%]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A479EE57-3AF5-434A-A1BB-63B2B172E402}"/>
              </a:ext>
            </a:extLst>
          </p:cNvPr>
          <p:cNvSpPr txBox="1"/>
          <p:nvPr/>
        </p:nvSpPr>
        <p:spPr>
          <a:xfrm>
            <a:off x="690036" y="3000740"/>
            <a:ext cx="2447423" cy="338554"/>
          </a:xfrm>
          <a:prstGeom prst="rect">
            <a:avLst/>
          </a:prstGeom>
          <a:noFill/>
          <a:ln w="38100"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eption (</a:t>
            </a:r>
            <a:r>
              <a:rPr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 [0.0%]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9AA6DF80-2F6C-654F-AA46-E31F6781C18E}"/>
              </a:ext>
            </a:extLst>
          </p:cNvPr>
          <p:cNvCxnSpPr>
            <a:cxnSpLocks/>
          </p:cNvCxnSpPr>
          <p:nvPr/>
        </p:nvCxnSpPr>
        <p:spPr>
          <a:xfrm flipH="1">
            <a:off x="2982317" y="4010051"/>
            <a:ext cx="1" cy="289746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835928E5-FC7F-834E-911E-CE17A814BF7B}"/>
              </a:ext>
            </a:extLst>
          </p:cNvPr>
          <p:cNvSpPr txBox="1"/>
          <p:nvPr/>
        </p:nvSpPr>
        <p:spPr>
          <a:xfrm>
            <a:off x="3270182" y="2858392"/>
            <a:ext cx="539915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out data of proteinuria at preeclampsia diagnosis or at delivery</a:t>
            </a: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4A9F5F45-8BB2-104A-8454-8F8599F35122}"/>
              </a:ext>
            </a:extLst>
          </p:cNvPr>
          <p:cNvSpPr txBox="1"/>
          <p:nvPr/>
        </p:nvSpPr>
        <p:spPr>
          <a:xfrm>
            <a:off x="5253832" y="1372737"/>
            <a:ext cx="302518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chronic hypertension or </a:t>
            </a:r>
          </a:p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uria as an underlying </a:t>
            </a:r>
          </a:p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ease at &lt;20 gestational weeks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43BB2FA-7D96-7C44-A23C-8185D942E13B}"/>
              </a:ext>
            </a:extLst>
          </p:cNvPr>
          <p:cNvSpPr txBox="1"/>
          <p:nvPr/>
        </p:nvSpPr>
        <p:spPr>
          <a:xfrm>
            <a:off x="690034" y="2337107"/>
            <a:ext cx="7324881" cy="338554"/>
          </a:xfrm>
          <a:prstGeom prst="rect">
            <a:avLst/>
          </a:prstGeom>
          <a:noFill/>
          <a:ln w="38100"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out onset of hypertension or proteinuria after conception </a:t>
            </a:r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2638 [90.8%]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1CAA733F-B5B5-584B-97BD-F712C2BB3CAD}"/>
              </a:ext>
            </a:extLst>
          </p:cNvPr>
          <p:cNvSpPr txBox="1"/>
          <p:nvPr/>
        </p:nvSpPr>
        <p:spPr>
          <a:xfrm>
            <a:off x="2863821" y="5414511"/>
            <a:ext cx="2902500" cy="830997"/>
          </a:xfrm>
          <a:prstGeom prst="rect">
            <a:avLst/>
          </a:prstGeom>
          <a:noFill/>
          <a:ln w="38100"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uria preceding</a:t>
            </a:r>
          </a:p>
          <a:p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eclampsia (P-PE) </a:t>
            </a:r>
          </a:p>
          <a:p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20 [0.7%])*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EE984596-EA89-6C47-B63E-10DFA1FC2ABD}"/>
              </a:ext>
            </a:extLst>
          </p:cNvPr>
          <p:cNvCxnSpPr>
            <a:cxnSpLocks/>
          </p:cNvCxnSpPr>
          <p:nvPr/>
        </p:nvCxnSpPr>
        <p:spPr>
          <a:xfrm>
            <a:off x="6164588" y="5178947"/>
            <a:ext cx="0" cy="235564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B9E21BE9-C62D-1442-9D3C-2C84D8E18F12}"/>
              </a:ext>
            </a:extLst>
          </p:cNvPr>
          <p:cNvSpPr txBox="1"/>
          <p:nvPr/>
        </p:nvSpPr>
        <p:spPr>
          <a:xfrm>
            <a:off x="5921341" y="5414511"/>
            <a:ext cx="2922500" cy="830997"/>
          </a:xfrm>
          <a:prstGeom prst="rect">
            <a:avLst/>
          </a:prstGeom>
          <a:noFill/>
          <a:ln w="38100"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pertension preceding</a:t>
            </a:r>
          </a:p>
          <a:p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eclampsia (H-PE) </a:t>
            </a:r>
          </a:p>
          <a:p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14 [0.5%])*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3735CB2D-A3EB-AB4F-B59E-A9624426B495}"/>
              </a:ext>
            </a:extLst>
          </p:cNvPr>
          <p:cNvCxnSpPr>
            <a:cxnSpLocks/>
          </p:cNvCxnSpPr>
          <p:nvPr/>
        </p:nvCxnSpPr>
        <p:spPr>
          <a:xfrm>
            <a:off x="441984" y="4871719"/>
            <a:ext cx="1" cy="548551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57623C2B-F472-F443-8738-4FB81D7490E7}"/>
              </a:ext>
            </a:extLst>
          </p:cNvPr>
          <p:cNvSpPr txBox="1"/>
          <p:nvPr/>
        </p:nvSpPr>
        <p:spPr>
          <a:xfrm>
            <a:off x="350516" y="5430455"/>
            <a:ext cx="2270057" cy="830997"/>
          </a:xfrm>
          <a:prstGeom prst="rect">
            <a:avLst/>
          </a:prstGeom>
          <a:noFill/>
          <a:ln w="38100"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multaneous preeclampsia (S-PE) </a:t>
            </a:r>
          </a:p>
          <a:p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60 [2.1%])*</a:t>
            </a:r>
            <a:endParaRPr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5CA8C63B-96E2-B34A-A062-9F7CE205FC7B}"/>
              </a:ext>
            </a:extLst>
          </p:cNvPr>
          <p:cNvCxnSpPr>
            <a:cxnSpLocks/>
          </p:cNvCxnSpPr>
          <p:nvPr/>
        </p:nvCxnSpPr>
        <p:spPr>
          <a:xfrm flipH="1">
            <a:off x="2979413" y="5178947"/>
            <a:ext cx="2906" cy="235564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E83D4CC4-981B-D344-9AC1-DB0E39FE0916}"/>
              </a:ext>
            </a:extLst>
          </p:cNvPr>
          <p:cNvCxnSpPr>
            <a:cxnSpLocks/>
          </p:cNvCxnSpPr>
          <p:nvPr/>
        </p:nvCxnSpPr>
        <p:spPr>
          <a:xfrm flipH="1">
            <a:off x="430588" y="5194992"/>
            <a:ext cx="5734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3EF7435B-5314-B546-90C8-947C342C2A35}"/>
              </a:ext>
            </a:extLst>
          </p:cNvPr>
          <p:cNvCxnSpPr>
            <a:cxnSpLocks/>
          </p:cNvCxnSpPr>
          <p:nvPr/>
        </p:nvCxnSpPr>
        <p:spPr>
          <a:xfrm>
            <a:off x="430588" y="3191942"/>
            <a:ext cx="259446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3630DC54-8968-BD4A-A83C-6C4F130FBD18}"/>
              </a:ext>
            </a:extLst>
          </p:cNvPr>
          <p:cNvCxnSpPr>
            <a:cxnSpLocks/>
            <a:endCxn id="25" idx="1"/>
          </p:cNvCxnSpPr>
          <p:nvPr/>
        </p:nvCxnSpPr>
        <p:spPr>
          <a:xfrm>
            <a:off x="441984" y="2506384"/>
            <a:ext cx="24805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AA18FD9E-2E9E-4F4C-96FE-293D04B6C0D3}"/>
              </a:ext>
            </a:extLst>
          </p:cNvPr>
          <p:cNvCxnSpPr>
            <a:cxnSpLocks/>
          </p:cNvCxnSpPr>
          <p:nvPr/>
        </p:nvCxnSpPr>
        <p:spPr>
          <a:xfrm>
            <a:off x="2720898" y="4181676"/>
            <a:ext cx="6372673" cy="0"/>
          </a:xfrm>
          <a:prstGeom prst="line">
            <a:avLst/>
          </a:prstGeom>
          <a:ln w="571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56431766-0067-3547-87BC-0B2D2BB3F95B}"/>
              </a:ext>
            </a:extLst>
          </p:cNvPr>
          <p:cNvCxnSpPr>
            <a:cxnSpLocks/>
          </p:cNvCxnSpPr>
          <p:nvPr/>
        </p:nvCxnSpPr>
        <p:spPr>
          <a:xfrm>
            <a:off x="9033115" y="4149676"/>
            <a:ext cx="0" cy="2536874"/>
          </a:xfrm>
          <a:prstGeom prst="line">
            <a:avLst/>
          </a:prstGeom>
          <a:ln w="571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7CACD1A9-7C9A-8446-A5B2-5C046DC9CAF4}"/>
              </a:ext>
            </a:extLst>
          </p:cNvPr>
          <p:cNvCxnSpPr>
            <a:cxnSpLocks/>
          </p:cNvCxnSpPr>
          <p:nvPr/>
        </p:nvCxnSpPr>
        <p:spPr>
          <a:xfrm>
            <a:off x="209550" y="6686550"/>
            <a:ext cx="8858330" cy="0"/>
          </a:xfrm>
          <a:prstGeom prst="line">
            <a:avLst/>
          </a:prstGeom>
          <a:ln w="571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0E7D28A2-2737-F740-B736-27C84D46DB02}"/>
              </a:ext>
            </a:extLst>
          </p:cNvPr>
          <p:cNvCxnSpPr>
            <a:cxnSpLocks/>
          </p:cNvCxnSpPr>
          <p:nvPr/>
        </p:nvCxnSpPr>
        <p:spPr>
          <a:xfrm>
            <a:off x="2753301" y="4149676"/>
            <a:ext cx="0" cy="958899"/>
          </a:xfrm>
          <a:prstGeom prst="line">
            <a:avLst/>
          </a:prstGeom>
          <a:ln w="571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753D7E17-C473-BF48-96ED-D1485C9E2078}"/>
              </a:ext>
            </a:extLst>
          </p:cNvPr>
          <p:cNvCxnSpPr>
            <a:cxnSpLocks/>
          </p:cNvCxnSpPr>
          <p:nvPr/>
        </p:nvCxnSpPr>
        <p:spPr>
          <a:xfrm>
            <a:off x="209550" y="5076825"/>
            <a:ext cx="2620156" cy="0"/>
          </a:xfrm>
          <a:prstGeom prst="line">
            <a:avLst/>
          </a:prstGeom>
          <a:ln w="571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F2688322-F897-6D4A-BFE7-1C10FF7B9824}"/>
              </a:ext>
            </a:extLst>
          </p:cNvPr>
          <p:cNvCxnSpPr>
            <a:cxnSpLocks/>
          </p:cNvCxnSpPr>
          <p:nvPr/>
        </p:nvCxnSpPr>
        <p:spPr>
          <a:xfrm>
            <a:off x="238384" y="5040203"/>
            <a:ext cx="0" cy="1646347"/>
          </a:xfrm>
          <a:prstGeom prst="line">
            <a:avLst/>
          </a:prstGeom>
          <a:ln w="571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13EC61C-D449-F04B-88A4-60CB8408B225}"/>
              </a:ext>
            </a:extLst>
          </p:cNvPr>
          <p:cNvSpPr txBox="1"/>
          <p:nvPr/>
        </p:nvSpPr>
        <p:spPr>
          <a:xfrm>
            <a:off x="291702" y="6255693"/>
            <a:ext cx="23385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ve groups in this study</a:t>
            </a:r>
            <a:endParaRPr kumimoji="1" lang="ja-JP" alt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F76DE8D7-15C4-104B-A2DC-97E518A2268A}"/>
              </a:ext>
            </a:extLst>
          </p:cNvPr>
          <p:cNvSpPr txBox="1"/>
          <p:nvPr/>
        </p:nvSpPr>
        <p:spPr>
          <a:xfrm>
            <a:off x="0" y="7058654"/>
            <a:ext cx="9129282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Study flowchart</a:t>
            </a:r>
            <a:endParaRPr lang="ja-JP" altLang="ja-JP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*The subjects of this study were classified in five groups: those with gestational proteinuria (GP; n = 14); those with gestational hypertension (GH; n = 75); those with proteinuria preceding preeclampsia (P-PE; n = 20), in which proteinuria as the initial symptom occurred at 20 weeks of pregnancy or later and hypertension developed ≥7 days later; those with hypertension preceding eclampsia (H-PE; n = 14), in which hypertension as the initial symptom occurred at 20 weeks of pregnancy or later and proteinuria developed ≥7 days later; and those in whom both proteinuria and hypertension developed within 6 days of one another at 20 weeks of pregnancy or later and before preeclampsia (“simultaneous preeclampsia” [S-PE]; n = 60).</a:t>
            </a:r>
            <a:endParaRPr lang="ja-JP" altLang="ja-JP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82507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7" id="{15B52F52-86A2-064F-82F8-E7F6234F133E}" vid="{BE814249-AB76-8544-879F-752AF5CB1740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テーマ</Template>
  <TotalTime>334</TotalTime>
  <Words>328</Words>
  <Application>Microsoft Macintosh PowerPoint</Application>
  <PresentationFormat>画面に合わせる (4:3)</PresentationFormat>
  <Paragraphs>2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守 森川</cp:lastModifiedBy>
  <cp:revision>51</cp:revision>
  <dcterms:created xsi:type="dcterms:W3CDTF">2020-04-24T23:10:07Z</dcterms:created>
  <dcterms:modified xsi:type="dcterms:W3CDTF">2021-05-12T14:06:20Z</dcterms:modified>
</cp:coreProperties>
</file>